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2" r:id="rId2"/>
    <p:sldId id="275" r:id="rId3"/>
    <p:sldId id="273" r:id="rId4"/>
    <p:sldId id="276" r:id="rId5"/>
    <p:sldId id="288" r:id="rId6"/>
    <p:sldId id="291" r:id="rId7"/>
    <p:sldId id="285" r:id="rId8"/>
    <p:sldId id="281" r:id="rId9"/>
    <p:sldId id="277" r:id="rId10"/>
    <p:sldId id="274" r:id="rId11"/>
    <p:sldId id="278" r:id="rId12"/>
    <p:sldId id="279" r:id="rId13"/>
    <p:sldId id="280" r:id="rId1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025" autoAdjust="0"/>
    <p:restoredTop sz="94658"/>
  </p:normalViewPr>
  <p:slideViewPr>
    <p:cSldViewPr snapToGrid="0">
      <p:cViewPr varScale="1">
        <p:scale>
          <a:sx n="120" d="100"/>
          <a:sy n="120" d="100"/>
        </p:scale>
        <p:origin x="64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4181BE-57FA-E075-5A6F-DFEA3BCB02E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BF8D805-66C5-DEDD-FC71-7D921B2254D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5D4BFC-1010-2B9D-D292-7A3FA5675F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5D82C-5D3C-4FAF-BD6A-1034D4350D0E}" type="datetimeFigureOut">
              <a:rPr lang="en-US" smtClean="0"/>
              <a:t>6/1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EC4229-7E2D-3A4F-F978-14653493F6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7DEE48-8D80-1367-BD8B-2DCDC6B2B9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81162-6219-4FEF-AA7A-1C5D3EA7F6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90585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855082-178B-CB42-E450-9C361A187A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26AE431-A234-CD2F-FD24-C1A4AFA4CA0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DBC18C-93C7-2331-771C-B344D805FC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5D82C-5D3C-4FAF-BD6A-1034D4350D0E}" type="datetimeFigureOut">
              <a:rPr lang="en-US" smtClean="0"/>
              <a:t>6/1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FFD1F64-A3D5-4BAF-61C8-DBE22C5864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A0BDE8-3FCF-E037-8A55-0A4782BA37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81162-6219-4FEF-AA7A-1C5D3EA7F6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3742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B18792C-0CA8-E211-BDA6-C0B20E96ED2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BD4646E-8D61-DADB-1300-C6E6A44451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84CCDC-8326-0505-14F1-BDD8B16ED6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5D82C-5D3C-4FAF-BD6A-1034D4350D0E}" type="datetimeFigureOut">
              <a:rPr lang="en-US" smtClean="0"/>
              <a:t>6/1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40DFF8-8D26-AA85-8294-0B02547EBD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2B0A5C-7D3C-7E21-4CBF-4BDA0E6436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81162-6219-4FEF-AA7A-1C5D3EA7F6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57668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AA3444-F8E7-0FCA-A1E7-4CE7DCA2D4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2ED848F-B138-DE3C-E59F-1EAE525AD5F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9B8F49-1122-3770-2738-A78C0FBB33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5D82C-5D3C-4FAF-BD6A-1034D4350D0E}" type="datetimeFigureOut">
              <a:rPr lang="en-US" smtClean="0"/>
              <a:t>6/1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FBDB12-31F7-D305-C176-6A151F82BF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31B448-F0B5-B48A-252E-411F1EC680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81162-6219-4FEF-AA7A-1C5D3EA7F6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5996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3A18C3-CFB7-0F4A-F960-711F393491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35A2994-5E9D-CA99-6D43-CE93131DB9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FB8EAD-9322-CABA-CB45-18486AA24D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5D82C-5D3C-4FAF-BD6A-1034D4350D0E}" type="datetimeFigureOut">
              <a:rPr lang="en-US" smtClean="0"/>
              <a:t>6/1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A52956-BEC0-AD42-DF50-659F3FC47D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21524F-538E-8DBE-B71E-1062E607BB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81162-6219-4FEF-AA7A-1C5D3EA7F6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83127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F2FEA8-A4FB-CCD1-DCC6-99B464AF25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F0C5153-4384-64F1-67D7-6085DE7AA4B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038CF54-FA1E-C48C-FA4D-6C6AD7DF44D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53F3C1C-0CD6-225A-D1AE-B29BB1E384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5D82C-5D3C-4FAF-BD6A-1034D4350D0E}" type="datetimeFigureOut">
              <a:rPr lang="en-US" smtClean="0"/>
              <a:t>6/1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0FAD952-D36E-304E-1508-B62E4C1EDF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A34D446-9026-8FFA-C3B2-6DAA6A1AFA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81162-6219-4FEF-AA7A-1C5D3EA7F6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05137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BB35E2-B88A-ED90-487F-49132AC036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F00183B-29D7-DBC6-7C82-69F3007D8F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FDA5E98-2DC4-96A8-C942-D894738C2D9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A1A1D98-CA7A-5677-CE6B-7CF892AE91C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C79D8C9-7306-00A8-DD40-8EF9DB770EE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0BD8C38-14F8-F742-58E3-8110612CF1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5D82C-5D3C-4FAF-BD6A-1034D4350D0E}" type="datetimeFigureOut">
              <a:rPr lang="en-US" smtClean="0"/>
              <a:t>6/1/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0A8C27E-41C0-5E67-40EB-3D700F94F5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62D2C15-E6A9-9476-E909-4F5A7F05A0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81162-6219-4FEF-AA7A-1C5D3EA7F6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91373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C2A9C5-AD8B-EBD6-0B0B-BAA03B2EC0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6B0407D-811A-09DA-62A4-6F5B95B48A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5D82C-5D3C-4FAF-BD6A-1034D4350D0E}" type="datetimeFigureOut">
              <a:rPr lang="en-US" smtClean="0"/>
              <a:t>6/1/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49008F8-5319-DB3E-45B3-6CE438A712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4465796-ECFB-1567-F150-C453990C9C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81162-6219-4FEF-AA7A-1C5D3EA7F6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34259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C375B92-E463-4B08-A967-5C585ED6A0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5D82C-5D3C-4FAF-BD6A-1034D4350D0E}" type="datetimeFigureOut">
              <a:rPr lang="en-US" smtClean="0"/>
              <a:t>6/1/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E175671-87F8-75DC-2A4A-D69ED6AE08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0C072C1-57CB-9029-B100-6D1D876B4B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81162-6219-4FEF-AA7A-1C5D3EA7F6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22727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6366A3-5F2C-0C07-DAD3-28D5B3A70D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66D371D-93D2-ED7E-9875-2A80D4B31D6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2F5CEB6-760F-0E0B-B1E0-F9E550E1565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EF650CF-9D37-7719-DEA7-A6B7FBEE62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5D82C-5D3C-4FAF-BD6A-1034D4350D0E}" type="datetimeFigureOut">
              <a:rPr lang="en-US" smtClean="0"/>
              <a:t>6/1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6241143-95A0-F4D3-44F9-EB55F1AF66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CD1D077-5516-20B3-31DF-6ABEB97468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81162-6219-4FEF-AA7A-1C5D3EA7F6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40473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1A1C98-CBE4-FE89-B1C1-5ECDD6DE4C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D1553B9-AC41-D2F3-40B8-789F2699E69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35262D9-5F26-8C35-BEA5-D1B5216D24F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AC71F8D-5A90-813F-4823-8D4FD387E7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15D82C-5D3C-4FAF-BD6A-1034D4350D0E}" type="datetimeFigureOut">
              <a:rPr lang="en-US" smtClean="0"/>
              <a:t>6/1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62E5EC5-A1FF-C3C2-1993-F9E6CC6143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2C00241-CA35-FD15-326C-7A930292C9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681162-6219-4FEF-AA7A-1C5D3EA7F6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86041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7EA3D2F-3DF1-ABEF-0D98-C424BF45CD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5EF726F-777B-5A1A-B090-3E334F6838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18E6A9-0D0B-FA32-A8E1-26680047FD5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315D82C-5D3C-4FAF-BD6A-1034D4350D0E}" type="datetimeFigureOut">
              <a:rPr lang="en-US" smtClean="0"/>
              <a:t>6/1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C34E07-6BF0-76D3-EC84-66C6D531296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6BBAD9-06AD-48FB-D06E-15E192F3DB2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8681162-6219-4FEF-AA7A-1C5D3EA7F6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08293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emf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4.png"/><Relationship Id="rId4" Type="http://schemas.openxmlformats.org/officeDocument/2006/relationships/image" Target="../media/image33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7.png"/><Relationship Id="rId4" Type="http://schemas.openxmlformats.org/officeDocument/2006/relationships/image" Target="../media/image36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png"/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0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emf"/><Relationship Id="rId5" Type="http://schemas.openxmlformats.org/officeDocument/2006/relationships/image" Target="../media/image6.emf"/><Relationship Id="rId4" Type="http://schemas.openxmlformats.org/officeDocument/2006/relationships/image" Target="../media/image5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1.emf"/><Relationship Id="rId4" Type="http://schemas.openxmlformats.org/officeDocument/2006/relationships/image" Target="../media/image10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emf"/><Relationship Id="rId5" Type="http://schemas.openxmlformats.org/officeDocument/2006/relationships/image" Target="../media/image15.emf"/><Relationship Id="rId4" Type="http://schemas.openxmlformats.org/officeDocument/2006/relationships/image" Target="../media/image14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emf"/><Relationship Id="rId5" Type="http://schemas.openxmlformats.org/officeDocument/2006/relationships/image" Target="../media/image20.emf"/><Relationship Id="rId4" Type="http://schemas.openxmlformats.org/officeDocument/2006/relationships/image" Target="../media/image19.emf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png"/><Relationship Id="rId3" Type="http://schemas.openxmlformats.org/officeDocument/2006/relationships/image" Target="../media/image23.png"/><Relationship Id="rId7" Type="http://schemas.openxmlformats.org/officeDocument/2006/relationships/image" Target="../media/image27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6.png"/><Relationship Id="rId5" Type="http://schemas.openxmlformats.org/officeDocument/2006/relationships/image" Target="../media/image25.png"/><Relationship Id="rId4" Type="http://schemas.openxmlformats.org/officeDocument/2006/relationships/image" Target="../media/image24.png"/><Relationship Id="rId9" Type="http://schemas.openxmlformats.org/officeDocument/2006/relationships/image" Target="../media/image2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ED324D2-0D9B-C517-9393-82524DDD26A7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t="-3864" r="66694"/>
          <a:stretch>
            <a:fillRect/>
          </a:stretch>
        </p:blipFill>
        <p:spPr>
          <a:xfrm>
            <a:off x="3484170" y="139326"/>
            <a:ext cx="5811084" cy="6040583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66097F61-191A-5605-EC1D-E9440D43AC90}"/>
              </a:ext>
            </a:extLst>
          </p:cNvPr>
          <p:cNvSpPr txBox="1"/>
          <p:nvPr/>
        </p:nvSpPr>
        <p:spPr>
          <a:xfrm>
            <a:off x="2461317" y="6179909"/>
            <a:ext cx="6387050" cy="3790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 1: Normalization</a:t>
            </a:r>
          </a:p>
        </p:txBody>
      </p:sp>
    </p:spTree>
    <p:extLst>
      <p:ext uri="{BB962C8B-B14F-4D97-AF65-F5344CB8AC3E}">
        <p14:creationId xmlns:p14="http://schemas.microsoft.com/office/powerpoint/2010/main" val="162999885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ABADA82-AAD4-52BF-8FEA-346D828B6D98}"/>
              </a:ext>
            </a:extLst>
          </p:cNvPr>
          <p:cNvSpPr txBox="1"/>
          <p:nvPr/>
        </p:nvSpPr>
        <p:spPr>
          <a:xfrm>
            <a:off x="2481942" y="6028655"/>
            <a:ext cx="63870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Supplemental Fig 10: Extracellular IGFBP-6 Levels after 50nM Abemaciclib and 1 </a:t>
            </a:r>
            <a:r>
              <a:rPr lang="en-US" dirty="0" err="1"/>
              <a:t>uM</a:t>
            </a:r>
            <a:r>
              <a:rPr lang="en-US" dirty="0"/>
              <a:t> Nocodazole Treatment.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FB7411CD-9C85-DF8A-063C-1F969686761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29000" y="1151659"/>
            <a:ext cx="5334000" cy="40005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BA291E9-5748-9CA0-BBE2-BF3C0D8B66AF}"/>
              </a:ext>
            </a:extLst>
          </p:cNvPr>
          <p:cNvSpPr txBox="1"/>
          <p:nvPr/>
        </p:nvSpPr>
        <p:spPr>
          <a:xfrm>
            <a:off x="6954983" y="1607127"/>
            <a:ext cx="533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***</a:t>
            </a:r>
          </a:p>
        </p:txBody>
      </p:sp>
    </p:spTree>
    <p:extLst>
      <p:ext uri="{BB962C8B-B14F-4D97-AF65-F5344CB8AC3E}">
        <p14:creationId xmlns:p14="http://schemas.microsoft.com/office/powerpoint/2010/main" val="163914251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he image appears to be a simplistic, monochromatic representation, likely a white background with a single black line or strip, suggesting minimal detail or a focus on minimalism.&#10;&#10;AI-generated content may be incorrect.">
            <a:extLst>
              <a:ext uri="{FF2B5EF4-FFF2-40B4-BE49-F238E27FC236}">
                <a16:creationId xmlns:a16="http://schemas.microsoft.com/office/drawing/2014/main" id="{63AADD58-F8C8-2878-CF9F-323A33E5C53E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41053" t="66956" r="29351" b="21605"/>
          <a:stretch>
            <a:fillRect/>
          </a:stretch>
        </p:blipFill>
        <p:spPr>
          <a:xfrm>
            <a:off x="7432963" y="1960417"/>
            <a:ext cx="3007925" cy="81049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CE30C082-EE54-C12B-ADE0-A5C198A07FBC}"/>
              </a:ext>
            </a:extLst>
          </p:cNvPr>
          <p:cNvSpPr txBox="1"/>
          <p:nvPr/>
        </p:nvSpPr>
        <p:spPr>
          <a:xfrm>
            <a:off x="6262254" y="2180997"/>
            <a:ext cx="11707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/>
              <a:t>IGFBP-6</a:t>
            </a:r>
          </a:p>
        </p:txBody>
      </p:sp>
      <p:pic>
        <p:nvPicPr>
          <p:cNvPr id="8" name="Picture 7" descr="The image appears to be a black and white striped pattern, possibly resembling a barcode or a series of horizontal lines.&#10;&#10;AI-generated content may be incorrect.">
            <a:extLst>
              <a:ext uri="{FF2B5EF4-FFF2-40B4-BE49-F238E27FC236}">
                <a16:creationId xmlns:a16="http://schemas.microsoft.com/office/drawing/2014/main" id="{AE36454A-1DAA-6EDD-ED88-F1B8E08696CF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42737" t="57354" r="27642" b="32432"/>
          <a:stretch>
            <a:fillRect/>
          </a:stretch>
        </p:blipFill>
        <p:spPr>
          <a:xfrm>
            <a:off x="7432963" y="2770909"/>
            <a:ext cx="3007925" cy="723059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26B4B465-6DC3-F42F-01AF-BC12C6E80A29}"/>
              </a:ext>
            </a:extLst>
          </p:cNvPr>
          <p:cNvSpPr txBox="1"/>
          <p:nvPr/>
        </p:nvSpPr>
        <p:spPr>
          <a:xfrm>
            <a:off x="8233806" y="706581"/>
            <a:ext cx="14062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Nocodazole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EEEDEA6-4202-E87B-A36C-17425B346475}"/>
              </a:ext>
            </a:extLst>
          </p:cNvPr>
          <p:cNvSpPr txBox="1"/>
          <p:nvPr/>
        </p:nvSpPr>
        <p:spPr>
          <a:xfrm>
            <a:off x="6262253" y="2770909"/>
            <a:ext cx="117070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/>
              <a:t>Beta Actin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4039EE93-5FCC-6E1F-575B-42FD6C385CB1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20095" t="60622" r="48860" b="26713"/>
          <a:stretch>
            <a:fillRect/>
          </a:stretch>
        </p:blipFill>
        <p:spPr>
          <a:xfrm>
            <a:off x="2415316" y="2147929"/>
            <a:ext cx="2622881" cy="745959"/>
          </a:xfrm>
          <a:prstGeom prst="rect">
            <a:avLst/>
          </a:prstGeom>
        </p:spPr>
      </p:pic>
      <p:pic>
        <p:nvPicPr>
          <p:cNvPr id="14" name="Picture 13" descr="The image appears to be a black and white striped line, potentially representing a DNA double helix or a similar pattern.&#10;&#10;AI-generated content may be incorrect.">
            <a:extLst>
              <a:ext uri="{FF2B5EF4-FFF2-40B4-BE49-F238E27FC236}">
                <a16:creationId xmlns:a16="http://schemas.microsoft.com/office/drawing/2014/main" id="{EAB5727A-2A6B-896A-9213-B056E40E0EAE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14113" t="62192" r="54415" b="25691"/>
          <a:stretch>
            <a:fillRect/>
          </a:stretch>
        </p:blipFill>
        <p:spPr>
          <a:xfrm>
            <a:off x="2432191" y="2893888"/>
            <a:ext cx="2589130" cy="694914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B8BD9CEB-067D-7117-04B3-DFE4F1542EFA}"/>
              </a:ext>
            </a:extLst>
          </p:cNvPr>
          <p:cNvSpPr txBox="1"/>
          <p:nvPr/>
        </p:nvSpPr>
        <p:spPr>
          <a:xfrm rot="16200000">
            <a:off x="2310700" y="1499136"/>
            <a:ext cx="928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A7AFCC2-6779-69BB-D5DB-651A6CF94C53}"/>
              </a:ext>
            </a:extLst>
          </p:cNvPr>
          <p:cNvSpPr txBox="1"/>
          <p:nvPr/>
        </p:nvSpPr>
        <p:spPr>
          <a:xfrm rot="16200000">
            <a:off x="2941727" y="1499136"/>
            <a:ext cx="928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5 </a:t>
            </a:r>
            <a:r>
              <a:rPr lang="en-US" dirty="0" err="1"/>
              <a:t>nM</a:t>
            </a:r>
            <a:endParaRPr lang="en-US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150D2BF-1DF0-5248-A96E-7EB9762800CE}"/>
              </a:ext>
            </a:extLst>
          </p:cNvPr>
          <p:cNvSpPr txBox="1"/>
          <p:nvPr/>
        </p:nvSpPr>
        <p:spPr>
          <a:xfrm rot="16200000">
            <a:off x="3554296" y="1499135"/>
            <a:ext cx="928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5 0 </a:t>
            </a:r>
            <a:r>
              <a:rPr lang="en-US" dirty="0" err="1"/>
              <a:t>nM</a:t>
            </a:r>
            <a:endParaRPr lang="en-US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4A9BC12-F3B7-2F1C-FCF2-0D7837AA9965}"/>
              </a:ext>
            </a:extLst>
          </p:cNvPr>
          <p:cNvSpPr txBox="1"/>
          <p:nvPr/>
        </p:nvSpPr>
        <p:spPr>
          <a:xfrm rot="16200000">
            <a:off x="4185323" y="1499136"/>
            <a:ext cx="928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500 </a:t>
            </a:r>
            <a:r>
              <a:rPr lang="en-US" dirty="0" err="1"/>
              <a:t>nM</a:t>
            </a:r>
            <a:endParaRPr lang="en-US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BDAD4B4-90A0-0921-1DFD-818C562C4C5C}"/>
              </a:ext>
            </a:extLst>
          </p:cNvPr>
          <p:cNvSpPr txBox="1"/>
          <p:nvPr/>
        </p:nvSpPr>
        <p:spPr>
          <a:xfrm rot="16200000">
            <a:off x="7352632" y="1331154"/>
            <a:ext cx="928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89157B60-ED84-49FF-D002-E0AA82B18863}"/>
              </a:ext>
            </a:extLst>
          </p:cNvPr>
          <p:cNvSpPr txBox="1"/>
          <p:nvPr/>
        </p:nvSpPr>
        <p:spPr>
          <a:xfrm rot="16200000">
            <a:off x="8074731" y="1329414"/>
            <a:ext cx="928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00 </a:t>
            </a:r>
            <a:r>
              <a:rPr lang="en-US" dirty="0" err="1"/>
              <a:t>nM</a:t>
            </a:r>
            <a:endParaRPr lang="en-US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2F0DA4F-AC72-5ED2-9626-3BD4D8AB74E5}"/>
              </a:ext>
            </a:extLst>
          </p:cNvPr>
          <p:cNvSpPr txBox="1"/>
          <p:nvPr/>
        </p:nvSpPr>
        <p:spPr>
          <a:xfrm rot="16200000">
            <a:off x="8837560" y="1329414"/>
            <a:ext cx="928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 </a:t>
            </a:r>
            <a:r>
              <a:rPr lang="en-US" dirty="0" err="1"/>
              <a:t>μM</a:t>
            </a:r>
            <a:endParaRPr lang="en-US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487458D-6637-2BCC-E57E-D6037ADF6254}"/>
              </a:ext>
            </a:extLst>
          </p:cNvPr>
          <p:cNvSpPr txBox="1"/>
          <p:nvPr/>
        </p:nvSpPr>
        <p:spPr>
          <a:xfrm rot="16200000">
            <a:off x="9468587" y="1329414"/>
            <a:ext cx="928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0 </a:t>
            </a:r>
            <a:r>
              <a:rPr lang="en-US" dirty="0" err="1"/>
              <a:t>μM</a:t>
            </a:r>
            <a:endParaRPr lang="en-US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B431C57D-6665-0801-07CA-7BBA57960216}"/>
              </a:ext>
            </a:extLst>
          </p:cNvPr>
          <p:cNvSpPr txBox="1"/>
          <p:nvPr/>
        </p:nvSpPr>
        <p:spPr>
          <a:xfrm>
            <a:off x="1261481" y="2256693"/>
            <a:ext cx="11707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/>
              <a:t>IGFBP-6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8F437FB-2A09-F901-07E2-B98469A2D8FB}"/>
              </a:ext>
            </a:extLst>
          </p:cNvPr>
          <p:cNvSpPr txBox="1"/>
          <p:nvPr/>
        </p:nvSpPr>
        <p:spPr>
          <a:xfrm>
            <a:off x="1261481" y="2868801"/>
            <a:ext cx="117070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/>
              <a:t>Beta Actin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9F832151-BB88-24EF-BED6-54E0CD42B7FB}"/>
              </a:ext>
            </a:extLst>
          </p:cNvPr>
          <p:cNvSpPr txBox="1"/>
          <p:nvPr/>
        </p:nvSpPr>
        <p:spPr>
          <a:xfrm>
            <a:off x="3009655" y="706581"/>
            <a:ext cx="14774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err="1"/>
              <a:t>Abemaciclib</a:t>
            </a:r>
            <a:endParaRPr lang="en-US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CBA7B594-A291-DF00-CD79-F7E2C42D63DE}"/>
              </a:ext>
            </a:extLst>
          </p:cNvPr>
          <p:cNvSpPr txBox="1"/>
          <p:nvPr/>
        </p:nvSpPr>
        <p:spPr>
          <a:xfrm>
            <a:off x="2753954" y="5159976"/>
            <a:ext cx="63870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 11: IGFBP-6 levels in Ishikawa Cells. Cells were treated with varying doses of </a:t>
            </a:r>
            <a:r>
              <a:rPr lang="en-US" dirty="0" err="1"/>
              <a:t>Abemaciclib</a:t>
            </a:r>
            <a:r>
              <a:rPr lang="en-US" dirty="0"/>
              <a:t> or Nocodazole. </a:t>
            </a:r>
          </a:p>
        </p:txBody>
      </p:sp>
    </p:spTree>
    <p:extLst>
      <p:ext uri="{BB962C8B-B14F-4D97-AF65-F5344CB8AC3E}">
        <p14:creationId xmlns:p14="http://schemas.microsoft.com/office/powerpoint/2010/main" val="46783638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he image appears to be a black and white diagram with a single line or bar, but without further context or additional details, it's impossible to provide a description.&#10;&#10;AI-generated content may be incorrect.">
            <a:extLst>
              <a:ext uri="{FF2B5EF4-FFF2-40B4-BE49-F238E27FC236}">
                <a16:creationId xmlns:a16="http://schemas.microsoft.com/office/drawing/2014/main" id="{A1AF675C-21FC-0E9C-D427-591809DB9DD8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50000" t="61643" r="18100" b="25692"/>
          <a:stretch>
            <a:fillRect/>
          </a:stretch>
        </p:blipFill>
        <p:spPr>
          <a:xfrm>
            <a:off x="2036312" y="2225429"/>
            <a:ext cx="2769323" cy="766507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60B09820-F14D-AC11-CD4D-BCEF6E10DEEA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55269" t="62257" r="12547" b="23852"/>
          <a:stretch>
            <a:fillRect/>
          </a:stretch>
        </p:blipFill>
        <p:spPr>
          <a:xfrm>
            <a:off x="2036312" y="3007368"/>
            <a:ext cx="2793053" cy="84039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A20682D7-C3A9-BD31-C69D-CC8FFE88F396}"/>
              </a:ext>
            </a:extLst>
          </p:cNvPr>
          <p:cNvSpPr txBox="1"/>
          <p:nvPr/>
        </p:nvSpPr>
        <p:spPr>
          <a:xfrm>
            <a:off x="5595162" y="2366907"/>
            <a:ext cx="11707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/>
              <a:t>IGFBP-6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DC3D959-541D-D358-7BC8-D64E7224DA3B}"/>
              </a:ext>
            </a:extLst>
          </p:cNvPr>
          <p:cNvSpPr txBox="1"/>
          <p:nvPr/>
        </p:nvSpPr>
        <p:spPr>
          <a:xfrm>
            <a:off x="5595163" y="3097199"/>
            <a:ext cx="117070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/>
              <a:t>Beta Actin</a:t>
            </a:r>
          </a:p>
        </p:txBody>
      </p:sp>
      <p:pic>
        <p:nvPicPr>
          <p:cNvPr id="12" name="Picture 11" descr="The image is a black and white abstract abstract with a single line.&#10;&#10;AI-generated content may be incorrect.">
            <a:extLst>
              <a:ext uri="{FF2B5EF4-FFF2-40B4-BE49-F238E27FC236}">
                <a16:creationId xmlns:a16="http://schemas.microsoft.com/office/drawing/2014/main" id="{1B8B1A26-12AF-11CC-90EA-4B1C9D542932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25079" t="59601" r="41455" b="27529"/>
          <a:stretch>
            <a:fillRect/>
          </a:stretch>
        </p:blipFill>
        <p:spPr>
          <a:xfrm>
            <a:off x="6765872" y="2177599"/>
            <a:ext cx="2611192" cy="700023"/>
          </a:xfrm>
          <a:prstGeom prst="rect">
            <a:avLst/>
          </a:prstGeom>
        </p:spPr>
      </p:pic>
      <p:pic>
        <p:nvPicPr>
          <p:cNvPr id="14" name="Picture 13" descr="The image is a black and white image with a single, unreadable word.&#10;&#10;AI-generated content may be incorrect.">
            <a:extLst>
              <a:ext uri="{FF2B5EF4-FFF2-40B4-BE49-F238E27FC236}">
                <a16:creationId xmlns:a16="http://schemas.microsoft.com/office/drawing/2014/main" id="{356745FA-2A59-C72D-D567-90D5EABD38DD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32484" t="43807" r="34477" b="39506"/>
          <a:stretch>
            <a:fillRect/>
          </a:stretch>
        </p:blipFill>
        <p:spPr>
          <a:xfrm>
            <a:off x="6765872" y="2901842"/>
            <a:ext cx="2636437" cy="928254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F5F681E1-BEB2-D375-B401-961D393F7860}"/>
              </a:ext>
            </a:extLst>
          </p:cNvPr>
          <p:cNvSpPr txBox="1"/>
          <p:nvPr/>
        </p:nvSpPr>
        <p:spPr>
          <a:xfrm rot="16200000">
            <a:off x="1953880" y="1576636"/>
            <a:ext cx="928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A7D32C7-4063-98F1-0073-09BFCD8308B8}"/>
              </a:ext>
            </a:extLst>
          </p:cNvPr>
          <p:cNvSpPr txBox="1"/>
          <p:nvPr/>
        </p:nvSpPr>
        <p:spPr>
          <a:xfrm rot="16200000">
            <a:off x="2600429" y="1557843"/>
            <a:ext cx="928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5 </a:t>
            </a:r>
            <a:r>
              <a:rPr lang="en-US" dirty="0" err="1"/>
              <a:t>nM</a:t>
            </a:r>
            <a:endParaRPr lang="en-US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884C97F-6644-C322-4115-E6E462456ADB}"/>
              </a:ext>
            </a:extLst>
          </p:cNvPr>
          <p:cNvSpPr txBox="1"/>
          <p:nvPr/>
        </p:nvSpPr>
        <p:spPr>
          <a:xfrm rot="16200000">
            <a:off x="3240027" y="1576636"/>
            <a:ext cx="928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5 0 </a:t>
            </a:r>
            <a:r>
              <a:rPr lang="en-US" dirty="0" err="1"/>
              <a:t>nM</a:t>
            </a:r>
            <a:endParaRPr lang="en-US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B7674C7-63A6-A1D2-AB69-92890B7B4A07}"/>
              </a:ext>
            </a:extLst>
          </p:cNvPr>
          <p:cNvSpPr txBox="1"/>
          <p:nvPr/>
        </p:nvSpPr>
        <p:spPr>
          <a:xfrm rot="16200000">
            <a:off x="3886576" y="1576636"/>
            <a:ext cx="928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500 </a:t>
            </a:r>
            <a:r>
              <a:rPr lang="en-US" dirty="0" err="1"/>
              <a:t>nM</a:t>
            </a:r>
            <a:endParaRPr lang="en-US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17D5E70-A948-081B-F58E-A74D19A6B30A}"/>
              </a:ext>
            </a:extLst>
          </p:cNvPr>
          <p:cNvSpPr txBox="1"/>
          <p:nvPr/>
        </p:nvSpPr>
        <p:spPr>
          <a:xfrm rot="16200000">
            <a:off x="6713569" y="1469050"/>
            <a:ext cx="928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DED3AE4-C7E5-1A83-7083-3DBF5E332404}"/>
              </a:ext>
            </a:extLst>
          </p:cNvPr>
          <p:cNvSpPr txBox="1"/>
          <p:nvPr/>
        </p:nvSpPr>
        <p:spPr>
          <a:xfrm rot="16200000">
            <a:off x="7310163" y="1505731"/>
            <a:ext cx="928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00 </a:t>
            </a:r>
            <a:r>
              <a:rPr lang="en-US" dirty="0" err="1"/>
              <a:t>nM</a:t>
            </a:r>
            <a:endParaRPr lang="en-US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526F8BB-D020-AFF4-3D0D-8725C3C12DEE}"/>
              </a:ext>
            </a:extLst>
          </p:cNvPr>
          <p:cNvSpPr txBox="1"/>
          <p:nvPr/>
        </p:nvSpPr>
        <p:spPr>
          <a:xfrm rot="16200000">
            <a:off x="7844043" y="1469050"/>
            <a:ext cx="928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 </a:t>
            </a:r>
            <a:r>
              <a:rPr lang="en-US" dirty="0" err="1"/>
              <a:t>μM</a:t>
            </a:r>
            <a:endParaRPr lang="en-US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CC33509-7D40-76E6-A47D-5E188874D758}"/>
              </a:ext>
            </a:extLst>
          </p:cNvPr>
          <p:cNvSpPr txBox="1"/>
          <p:nvPr/>
        </p:nvSpPr>
        <p:spPr>
          <a:xfrm rot="16200000">
            <a:off x="8456611" y="1469050"/>
            <a:ext cx="928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0 </a:t>
            </a:r>
            <a:r>
              <a:rPr lang="en-US" dirty="0" err="1"/>
              <a:t>μM</a:t>
            </a:r>
            <a:endParaRPr lang="en-US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FCA3F9C6-F468-F554-3647-AD2F0C1F3924}"/>
              </a:ext>
            </a:extLst>
          </p:cNvPr>
          <p:cNvSpPr txBox="1"/>
          <p:nvPr/>
        </p:nvSpPr>
        <p:spPr>
          <a:xfrm>
            <a:off x="865603" y="2508290"/>
            <a:ext cx="11707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/>
              <a:t>IGFBP-6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B7FFB61-4B75-A826-16C0-1159EF1D1554}"/>
              </a:ext>
            </a:extLst>
          </p:cNvPr>
          <p:cNvSpPr txBox="1"/>
          <p:nvPr/>
        </p:nvSpPr>
        <p:spPr>
          <a:xfrm>
            <a:off x="865603" y="3097200"/>
            <a:ext cx="117070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/>
              <a:t>Beta Actin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124760E9-91D1-BD64-7A36-6572363A4B4E}"/>
              </a:ext>
            </a:extLst>
          </p:cNvPr>
          <p:cNvSpPr txBox="1"/>
          <p:nvPr/>
        </p:nvSpPr>
        <p:spPr>
          <a:xfrm>
            <a:off x="7362363" y="722579"/>
            <a:ext cx="14062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Nocodazole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CE1A4D73-A9C3-20ED-5921-6CF3F46F4FE5}"/>
              </a:ext>
            </a:extLst>
          </p:cNvPr>
          <p:cNvSpPr txBox="1"/>
          <p:nvPr/>
        </p:nvSpPr>
        <p:spPr>
          <a:xfrm>
            <a:off x="2602673" y="722579"/>
            <a:ext cx="14774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err="1"/>
              <a:t>Abemaciclib</a:t>
            </a:r>
            <a:endParaRPr lang="en-US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0852DF4-E4AE-AB20-AF40-03BEAF4388B1}"/>
              </a:ext>
            </a:extLst>
          </p:cNvPr>
          <p:cNvSpPr txBox="1"/>
          <p:nvPr/>
        </p:nvSpPr>
        <p:spPr>
          <a:xfrm>
            <a:off x="2753954" y="5159976"/>
            <a:ext cx="638705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 12: IGFBP-6 levels in MDA-MB-231 Cells. Cells were treated with varying doses of </a:t>
            </a:r>
            <a:r>
              <a:rPr lang="en-US" dirty="0" err="1"/>
              <a:t>Abemaciclib</a:t>
            </a:r>
            <a:r>
              <a:rPr lang="en-US" dirty="0"/>
              <a:t> or Nocodazole. </a:t>
            </a:r>
          </a:p>
        </p:txBody>
      </p:sp>
    </p:spTree>
    <p:extLst>
      <p:ext uri="{BB962C8B-B14F-4D97-AF65-F5344CB8AC3E}">
        <p14:creationId xmlns:p14="http://schemas.microsoft.com/office/powerpoint/2010/main" val="91961181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The image appears to be a black and white striped line, potentially resembling a linear DNA strand or a barcode.&#10;&#10;AI-generated content may be incorrect.">
            <a:extLst>
              <a:ext uri="{FF2B5EF4-FFF2-40B4-BE49-F238E27FC236}">
                <a16:creationId xmlns:a16="http://schemas.microsoft.com/office/drawing/2014/main" id="{E8B5C83C-7804-9508-C169-E16B208887B3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44158" t="50000" r="30205" b="40005"/>
          <a:stretch>
            <a:fillRect/>
          </a:stretch>
        </p:blipFill>
        <p:spPr>
          <a:xfrm>
            <a:off x="2878280" y="2870293"/>
            <a:ext cx="2334491" cy="634453"/>
          </a:xfrm>
          <a:prstGeom prst="rect">
            <a:avLst/>
          </a:prstGeom>
        </p:spPr>
      </p:pic>
      <p:pic>
        <p:nvPicPr>
          <p:cNvPr id="7" name="Picture 6" descr="The image appears to be a black and white image with a single, elongated white line or strip, possibly resembling a DNA strand or a line of text.&#10;&#10;AI-generated content may be incorrect.">
            <a:extLst>
              <a:ext uri="{FF2B5EF4-FFF2-40B4-BE49-F238E27FC236}">
                <a16:creationId xmlns:a16="http://schemas.microsoft.com/office/drawing/2014/main" id="{5B2D903F-10CA-B9F6-2FA6-3FEE7E0575E2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51851" t="40603" r="22942" b="47753"/>
          <a:stretch>
            <a:fillRect/>
          </a:stretch>
        </p:blipFill>
        <p:spPr>
          <a:xfrm>
            <a:off x="7363692" y="3505526"/>
            <a:ext cx="2421326" cy="779750"/>
          </a:xfrm>
          <a:prstGeom prst="rect">
            <a:avLst/>
          </a:prstGeom>
        </p:spPr>
      </p:pic>
      <p:pic>
        <p:nvPicPr>
          <p:cNvPr id="9" name="Picture 8" descr="The image appears to be a black and white striped pattern, potentially representing a lineage or gene sequence.&#10;&#10;AI-generated content may be incorrect.">
            <a:extLst>
              <a:ext uri="{FF2B5EF4-FFF2-40B4-BE49-F238E27FC236}">
                <a16:creationId xmlns:a16="http://schemas.microsoft.com/office/drawing/2014/main" id="{731B64AC-A7F1-1C0E-56F1-30A086D49342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25933" t="45301" r="43877" b="40195"/>
          <a:stretch>
            <a:fillRect/>
          </a:stretch>
        </p:blipFill>
        <p:spPr>
          <a:xfrm>
            <a:off x="2884511" y="3501310"/>
            <a:ext cx="2328260" cy="779750"/>
          </a:xfrm>
          <a:prstGeom prst="rect">
            <a:avLst/>
          </a:prstGeom>
        </p:spPr>
      </p:pic>
      <p:pic>
        <p:nvPicPr>
          <p:cNvPr id="10" name="Picture 9" descr="The image appears to be a black and white striped line, potentially resembling a linear DNA strand or a barcode.&#10;&#10;AI-generated content may be incorrect.">
            <a:extLst>
              <a:ext uri="{FF2B5EF4-FFF2-40B4-BE49-F238E27FC236}">
                <a16:creationId xmlns:a16="http://schemas.microsoft.com/office/drawing/2014/main" id="{91488160-18C6-9D39-84F8-DD2921FE2939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17531" t="50000" r="55766" b="41069"/>
          <a:stretch>
            <a:fillRect/>
          </a:stretch>
        </p:blipFill>
        <p:spPr>
          <a:xfrm>
            <a:off x="7312131" y="2974944"/>
            <a:ext cx="2431473" cy="566912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7430163F-B428-8A52-9265-7FB931A1BAE4}"/>
              </a:ext>
            </a:extLst>
          </p:cNvPr>
          <p:cNvSpPr txBox="1"/>
          <p:nvPr/>
        </p:nvSpPr>
        <p:spPr>
          <a:xfrm rot="16200000">
            <a:off x="2665740" y="2216127"/>
            <a:ext cx="928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ACD7794-6B5B-3E97-5E02-0EF3EC99E3AC}"/>
              </a:ext>
            </a:extLst>
          </p:cNvPr>
          <p:cNvSpPr txBox="1"/>
          <p:nvPr/>
        </p:nvSpPr>
        <p:spPr>
          <a:xfrm rot="16200000">
            <a:off x="3260372" y="2216128"/>
            <a:ext cx="928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5 </a:t>
            </a:r>
            <a:r>
              <a:rPr lang="en-US" dirty="0" err="1"/>
              <a:t>nM</a:t>
            </a:r>
            <a:endParaRPr lang="en-US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0312E61-F18E-F0BF-58B3-01E952A1A14A}"/>
              </a:ext>
            </a:extLst>
          </p:cNvPr>
          <p:cNvSpPr txBox="1"/>
          <p:nvPr/>
        </p:nvSpPr>
        <p:spPr>
          <a:xfrm rot="16200000">
            <a:off x="3799086" y="2221499"/>
            <a:ext cx="928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5 0 </a:t>
            </a:r>
            <a:r>
              <a:rPr lang="en-US" dirty="0" err="1"/>
              <a:t>nM</a:t>
            </a:r>
            <a:endParaRPr lang="en-US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3002CB1-AC13-CB2F-0370-2E432E15BEC8}"/>
              </a:ext>
            </a:extLst>
          </p:cNvPr>
          <p:cNvSpPr txBox="1"/>
          <p:nvPr/>
        </p:nvSpPr>
        <p:spPr>
          <a:xfrm rot="16200000">
            <a:off x="4382370" y="2221500"/>
            <a:ext cx="928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500 </a:t>
            </a:r>
            <a:r>
              <a:rPr lang="en-US" dirty="0" err="1"/>
              <a:t>nM</a:t>
            </a:r>
            <a:endParaRPr lang="en-US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54E278E-4D1C-804C-EE89-BF8B67F3E421}"/>
              </a:ext>
            </a:extLst>
          </p:cNvPr>
          <p:cNvSpPr txBox="1"/>
          <p:nvPr/>
        </p:nvSpPr>
        <p:spPr>
          <a:xfrm rot="16200000">
            <a:off x="7211946" y="2326151"/>
            <a:ext cx="928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F8302FA-DFEA-9DD1-771C-7846BEE958BD}"/>
              </a:ext>
            </a:extLst>
          </p:cNvPr>
          <p:cNvSpPr txBox="1"/>
          <p:nvPr/>
        </p:nvSpPr>
        <p:spPr>
          <a:xfrm rot="16200000">
            <a:off x="7827553" y="2326151"/>
            <a:ext cx="928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00 </a:t>
            </a:r>
            <a:r>
              <a:rPr lang="en-US" dirty="0" err="1"/>
              <a:t>nM</a:t>
            </a:r>
            <a:endParaRPr lang="en-US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565AEA1-D8B3-164C-2151-4E6E41D45ABD}"/>
              </a:ext>
            </a:extLst>
          </p:cNvPr>
          <p:cNvSpPr txBox="1"/>
          <p:nvPr/>
        </p:nvSpPr>
        <p:spPr>
          <a:xfrm rot="16200000">
            <a:off x="8397472" y="2326151"/>
            <a:ext cx="928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 </a:t>
            </a:r>
            <a:r>
              <a:rPr lang="en-US" dirty="0" err="1"/>
              <a:t>μM</a:t>
            </a:r>
            <a:endParaRPr lang="en-US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2B54022-EF36-D1E8-54C1-36679966FD3A}"/>
              </a:ext>
            </a:extLst>
          </p:cNvPr>
          <p:cNvSpPr txBox="1"/>
          <p:nvPr/>
        </p:nvSpPr>
        <p:spPr>
          <a:xfrm rot="16200000">
            <a:off x="8967391" y="2326151"/>
            <a:ext cx="928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0 </a:t>
            </a:r>
            <a:r>
              <a:rPr lang="en-US" dirty="0" err="1"/>
              <a:t>μM</a:t>
            </a:r>
            <a:endParaRPr lang="en-US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C9E9C1B-AAC8-F762-9B21-33D28A27A669}"/>
              </a:ext>
            </a:extLst>
          </p:cNvPr>
          <p:cNvSpPr txBox="1"/>
          <p:nvPr/>
        </p:nvSpPr>
        <p:spPr>
          <a:xfrm>
            <a:off x="7973814" y="1596733"/>
            <a:ext cx="14062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Nocodazole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98D69B1-D256-C04E-88F8-A18C336378B6}"/>
              </a:ext>
            </a:extLst>
          </p:cNvPr>
          <p:cNvSpPr txBox="1"/>
          <p:nvPr/>
        </p:nvSpPr>
        <p:spPr>
          <a:xfrm>
            <a:off x="3255223" y="1596733"/>
            <a:ext cx="14774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err="1"/>
              <a:t>Abemaciclib</a:t>
            </a:r>
            <a:endParaRPr lang="en-US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DEE641F-DD28-BE25-E928-BF6203F26BC8}"/>
              </a:ext>
            </a:extLst>
          </p:cNvPr>
          <p:cNvSpPr txBox="1"/>
          <p:nvPr/>
        </p:nvSpPr>
        <p:spPr>
          <a:xfrm>
            <a:off x="1710686" y="3045819"/>
            <a:ext cx="11707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/>
              <a:t>IGFBP-6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89D1190-B49D-99EF-6E70-535F230ACE1B}"/>
              </a:ext>
            </a:extLst>
          </p:cNvPr>
          <p:cNvSpPr txBox="1"/>
          <p:nvPr/>
        </p:nvSpPr>
        <p:spPr>
          <a:xfrm>
            <a:off x="1710686" y="3634729"/>
            <a:ext cx="117070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/>
              <a:t>Beta Actin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E4A97838-6CC9-4D5D-DB11-786F60FFDB78}"/>
              </a:ext>
            </a:extLst>
          </p:cNvPr>
          <p:cNvSpPr txBox="1"/>
          <p:nvPr/>
        </p:nvSpPr>
        <p:spPr>
          <a:xfrm>
            <a:off x="6192983" y="3045819"/>
            <a:ext cx="11707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/>
              <a:t>IGFBP-6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6EE82719-FEB4-A126-8975-36BA50C19120}"/>
              </a:ext>
            </a:extLst>
          </p:cNvPr>
          <p:cNvSpPr txBox="1"/>
          <p:nvPr/>
        </p:nvSpPr>
        <p:spPr>
          <a:xfrm>
            <a:off x="6192983" y="3634729"/>
            <a:ext cx="117070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/>
              <a:t>Beta Actin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958043B-D16E-1E15-C0DC-4BD02B4E9C07}"/>
              </a:ext>
            </a:extLst>
          </p:cNvPr>
          <p:cNvSpPr txBox="1"/>
          <p:nvPr/>
        </p:nvSpPr>
        <p:spPr>
          <a:xfrm>
            <a:off x="2753954" y="5159976"/>
            <a:ext cx="638705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 13: IGFBP-6 levels in MDA-MB-468 Cells. Cells were treated with varying doses of </a:t>
            </a:r>
            <a:r>
              <a:rPr lang="en-US" dirty="0" err="1"/>
              <a:t>Abemaciclib</a:t>
            </a:r>
            <a:r>
              <a:rPr lang="en-US" dirty="0"/>
              <a:t> or Nocodazole. </a:t>
            </a:r>
          </a:p>
        </p:txBody>
      </p:sp>
    </p:spTree>
    <p:extLst>
      <p:ext uri="{BB962C8B-B14F-4D97-AF65-F5344CB8AC3E}">
        <p14:creationId xmlns:p14="http://schemas.microsoft.com/office/powerpoint/2010/main" val="26098029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268E927B-BF36-53FA-E97F-D8AA962FA86E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33227" t="-3864" r="32784"/>
          <a:stretch>
            <a:fillRect/>
          </a:stretch>
        </p:blipFill>
        <p:spPr>
          <a:xfrm>
            <a:off x="3382593" y="118701"/>
            <a:ext cx="5930254" cy="6040583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3FD76E0-8584-19B1-04D9-B8CDA157A097}"/>
              </a:ext>
            </a:extLst>
          </p:cNvPr>
          <p:cNvSpPr txBox="1"/>
          <p:nvPr/>
        </p:nvSpPr>
        <p:spPr>
          <a:xfrm>
            <a:off x="2461317" y="6179909"/>
            <a:ext cx="6387050" cy="3790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 2: Principal Components Analysis</a:t>
            </a:r>
          </a:p>
        </p:txBody>
      </p:sp>
    </p:spTree>
    <p:extLst>
      <p:ext uri="{BB962C8B-B14F-4D97-AF65-F5344CB8AC3E}">
        <p14:creationId xmlns:p14="http://schemas.microsoft.com/office/powerpoint/2010/main" val="20386659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6539578-4CC9-B6BD-E3F6-67CAEEBA54AA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67102" t="-1137"/>
          <a:stretch>
            <a:fillRect/>
          </a:stretch>
        </p:blipFill>
        <p:spPr>
          <a:xfrm>
            <a:off x="3201915" y="406908"/>
            <a:ext cx="5898173" cy="6044184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4AF1A9DC-509C-914A-75FE-E4C0BD17679A}"/>
              </a:ext>
            </a:extLst>
          </p:cNvPr>
          <p:cNvSpPr txBox="1"/>
          <p:nvPr/>
        </p:nvSpPr>
        <p:spPr>
          <a:xfrm>
            <a:off x="2461317" y="6179909"/>
            <a:ext cx="6387050" cy="3790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 3: Hierarchical Clustering</a:t>
            </a:r>
          </a:p>
        </p:txBody>
      </p:sp>
    </p:spTree>
    <p:extLst>
      <p:ext uri="{BB962C8B-B14F-4D97-AF65-F5344CB8AC3E}">
        <p14:creationId xmlns:p14="http://schemas.microsoft.com/office/powerpoint/2010/main" val="232165073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D84A1D58-27A8-DC26-FCED-786C8072C6E6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31818" r="31478"/>
          <a:stretch>
            <a:fillRect/>
          </a:stretch>
        </p:blipFill>
        <p:spPr>
          <a:xfrm>
            <a:off x="2892942" y="104400"/>
            <a:ext cx="6655472" cy="6044184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3CB2214A-BF24-B13D-F38C-1218655D6A0F}"/>
              </a:ext>
            </a:extLst>
          </p:cNvPr>
          <p:cNvSpPr txBox="1"/>
          <p:nvPr/>
        </p:nvSpPr>
        <p:spPr>
          <a:xfrm>
            <a:off x="2461317" y="6179909"/>
            <a:ext cx="6387050" cy="3790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 4: Correlation Plot</a:t>
            </a:r>
          </a:p>
        </p:txBody>
      </p:sp>
    </p:spTree>
    <p:extLst>
      <p:ext uri="{BB962C8B-B14F-4D97-AF65-F5344CB8AC3E}">
        <p14:creationId xmlns:p14="http://schemas.microsoft.com/office/powerpoint/2010/main" val="38522124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29239E36-CBFC-0B09-D1C1-DBAABD7D2F8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66553" y="116959"/>
            <a:ext cx="3657600" cy="27432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A119E8E-0521-AABB-A638-A2518DF7DE2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24153" y="0"/>
            <a:ext cx="3657600" cy="274320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8634AD26-8E55-BC9A-75BA-E9F6A9CD78A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181753" y="116959"/>
            <a:ext cx="3657600" cy="274320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657D34AF-C565-9431-93D2-9EF2BB7E18E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533134" y="2743200"/>
            <a:ext cx="3657600" cy="27432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F9225278-DC94-B046-C557-2CA82072810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457555" y="2743200"/>
            <a:ext cx="3657600" cy="27432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1AB4FA37-B98F-AD9F-E3A0-D1471CF763D3}"/>
              </a:ext>
            </a:extLst>
          </p:cNvPr>
          <p:cNvSpPr txBox="1"/>
          <p:nvPr/>
        </p:nvSpPr>
        <p:spPr>
          <a:xfrm>
            <a:off x="2168611" y="5540712"/>
            <a:ext cx="921814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 5: Densitometry following PR inhibition. All  targets were statistically tested using ANOVA. </a:t>
            </a:r>
            <a:r>
              <a:rPr lang="en-US" dirty="0" err="1"/>
              <a:t>All</a:t>
            </a:r>
            <a:r>
              <a:rPr lang="en-US" dirty="0"/>
              <a:t> asterisks represent statistical significance relative to cells treated with the vehicle. * means p&lt; 0.05, *** means p&lt;0.01, and *** means p&lt;0.001. 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1AF79AC-4DEE-9938-4ED8-EB65DB963737}"/>
              </a:ext>
            </a:extLst>
          </p:cNvPr>
          <p:cNvSpPr txBox="1"/>
          <p:nvPr/>
        </p:nvSpPr>
        <p:spPr>
          <a:xfrm>
            <a:off x="2466679" y="1568458"/>
            <a:ext cx="3901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***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C47643B-E814-9FFB-B960-AA0450DB8431}"/>
              </a:ext>
            </a:extLst>
          </p:cNvPr>
          <p:cNvSpPr txBox="1"/>
          <p:nvPr/>
        </p:nvSpPr>
        <p:spPr>
          <a:xfrm>
            <a:off x="2929798" y="1552182"/>
            <a:ext cx="3901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***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59938AA-75E7-FFAB-693C-C9543035154E}"/>
              </a:ext>
            </a:extLst>
          </p:cNvPr>
          <p:cNvSpPr txBox="1"/>
          <p:nvPr/>
        </p:nvSpPr>
        <p:spPr>
          <a:xfrm>
            <a:off x="3382559" y="1578815"/>
            <a:ext cx="3901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***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1060880-6DC0-09FA-A6CB-2FDFE7A7A94E}"/>
              </a:ext>
            </a:extLst>
          </p:cNvPr>
          <p:cNvSpPr txBox="1"/>
          <p:nvPr/>
        </p:nvSpPr>
        <p:spPr>
          <a:xfrm>
            <a:off x="6099126" y="1365751"/>
            <a:ext cx="3901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***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F756E6F-9A12-1162-185D-DB981ABD301A}"/>
              </a:ext>
            </a:extLst>
          </p:cNvPr>
          <p:cNvSpPr txBox="1"/>
          <p:nvPr/>
        </p:nvSpPr>
        <p:spPr>
          <a:xfrm>
            <a:off x="6587398" y="1347996"/>
            <a:ext cx="3901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***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CBC31ED-CD27-08BE-79C0-270AA4D4A97A}"/>
              </a:ext>
            </a:extLst>
          </p:cNvPr>
          <p:cNvSpPr txBox="1"/>
          <p:nvPr/>
        </p:nvSpPr>
        <p:spPr>
          <a:xfrm>
            <a:off x="7057914" y="1321362"/>
            <a:ext cx="3901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***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7C3DE24-DBD2-AEB2-E14B-FF21EA8BCBCC}"/>
              </a:ext>
            </a:extLst>
          </p:cNvPr>
          <p:cNvSpPr txBox="1"/>
          <p:nvPr/>
        </p:nvSpPr>
        <p:spPr>
          <a:xfrm>
            <a:off x="9614683" y="140632"/>
            <a:ext cx="3901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*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43F74BA-A8BD-A594-5630-76F359B7AFBB}"/>
              </a:ext>
            </a:extLst>
          </p:cNvPr>
          <p:cNvSpPr txBox="1"/>
          <p:nvPr/>
        </p:nvSpPr>
        <p:spPr>
          <a:xfrm>
            <a:off x="3969964" y="2761024"/>
            <a:ext cx="3901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239212392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8DE5B91E-57CC-8703-B3EE-BFB0D2A8FB8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22590" y="306166"/>
            <a:ext cx="3657600" cy="27432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95C97B4E-EF58-B004-22A1-F836591AE2B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77681" y="-17209"/>
            <a:ext cx="3657600" cy="27432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70CC6108-A1C0-FF74-B64B-5EF898766557}"/>
              </a:ext>
            </a:extLst>
          </p:cNvPr>
          <p:cNvSpPr txBox="1"/>
          <p:nvPr/>
        </p:nvSpPr>
        <p:spPr>
          <a:xfrm>
            <a:off x="2175976" y="59371"/>
            <a:ext cx="14460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T47D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723DF15-E230-C722-9CB2-A06A1C7B2FB6}"/>
              </a:ext>
            </a:extLst>
          </p:cNvPr>
          <p:cNvSpPr txBox="1"/>
          <p:nvPr/>
        </p:nvSpPr>
        <p:spPr>
          <a:xfrm>
            <a:off x="7814776" y="59371"/>
            <a:ext cx="14460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MCF7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23D6D6C3-EE1C-81A3-480D-AE23F96B4CE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22590" y="2588354"/>
            <a:ext cx="3657600" cy="274320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CCED0BA9-D357-789F-607A-5FF5AB93549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777681" y="2588354"/>
            <a:ext cx="3657600" cy="274320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9968190D-9FCE-FCC5-A122-B164C88FA8F2}"/>
              </a:ext>
            </a:extLst>
          </p:cNvPr>
          <p:cNvSpPr txBox="1"/>
          <p:nvPr/>
        </p:nvSpPr>
        <p:spPr>
          <a:xfrm>
            <a:off x="1486930" y="5628504"/>
            <a:ext cx="921814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 6: Densitometry Following Abemaciclib Treatments. MCF7 cells did not have significant changes. All  targets were statistically tested using ANOVA. </a:t>
            </a:r>
            <a:r>
              <a:rPr lang="en-US" dirty="0" err="1"/>
              <a:t>All</a:t>
            </a:r>
            <a:r>
              <a:rPr lang="en-US" dirty="0"/>
              <a:t> asterisks represent statistical significance relative to cells treated with the vehicle. * means p&lt; 0.05, *** means p&lt;0.01, and *** means p&lt;0.001. 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B3E7056-F923-1AB3-6A9F-BB0EFBF9B97A}"/>
              </a:ext>
            </a:extLst>
          </p:cNvPr>
          <p:cNvSpPr txBox="1"/>
          <p:nvPr/>
        </p:nvSpPr>
        <p:spPr>
          <a:xfrm>
            <a:off x="3293703" y="1316455"/>
            <a:ext cx="3901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*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59E7EB9-BFD4-28BB-DEA2-6E6B2369F9D3}"/>
              </a:ext>
            </a:extLst>
          </p:cNvPr>
          <p:cNvSpPr txBox="1"/>
          <p:nvPr/>
        </p:nvSpPr>
        <p:spPr>
          <a:xfrm>
            <a:off x="3767571" y="1311693"/>
            <a:ext cx="3901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*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40E34B4-0FAB-B5D0-A253-EA7233613CB7}"/>
              </a:ext>
            </a:extLst>
          </p:cNvPr>
          <p:cNvSpPr txBox="1"/>
          <p:nvPr/>
        </p:nvSpPr>
        <p:spPr>
          <a:xfrm>
            <a:off x="3767572" y="3469105"/>
            <a:ext cx="3901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*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03FD472-C978-3BEF-69BB-62BE86F82E2C}"/>
              </a:ext>
            </a:extLst>
          </p:cNvPr>
          <p:cNvSpPr txBox="1"/>
          <p:nvPr/>
        </p:nvSpPr>
        <p:spPr>
          <a:xfrm>
            <a:off x="2817453" y="4212055"/>
            <a:ext cx="3901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***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6A1F2DF-A681-7299-9231-AA026959879E}"/>
              </a:ext>
            </a:extLst>
          </p:cNvPr>
          <p:cNvSpPr txBox="1"/>
          <p:nvPr/>
        </p:nvSpPr>
        <p:spPr>
          <a:xfrm>
            <a:off x="3298465" y="4321593"/>
            <a:ext cx="3901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***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40AA35C-9155-3C12-8E8C-CB91CE3A4FE8}"/>
              </a:ext>
            </a:extLst>
          </p:cNvPr>
          <p:cNvSpPr txBox="1"/>
          <p:nvPr/>
        </p:nvSpPr>
        <p:spPr>
          <a:xfrm>
            <a:off x="1972037" y="2633294"/>
            <a:ext cx="25936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Abemaciclib Dose (</a:t>
            </a:r>
            <a:r>
              <a:rPr lang="en-US" sz="1600" dirty="0" err="1"/>
              <a:t>nM</a:t>
            </a:r>
            <a:r>
              <a:rPr lang="en-US" sz="1600" dirty="0"/>
              <a:t>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8513382-46D4-FE54-6DC4-576129F76AA1}"/>
              </a:ext>
            </a:extLst>
          </p:cNvPr>
          <p:cNvSpPr txBox="1"/>
          <p:nvPr/>
        </p:nvSpPr>
        <p:spPr>
          <a:xfrm>
            <a:off x="7552837" y="2633294"/>
            <a:ext cx="25936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Abemaciclib Dose (</a:t>
            </a:r>
            <a:r>
              <a:rPr lang="en-US" sz="1600" dirty="0" err="1"/>
              <a:t>nM</a:t>
            </a:r>
            <a:r>
              <a:rPr lang="en-US" sz="1600" dirty="0"/>
              <a:t>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BB1D92D-0B01-AC00-88A2-0150B42E1A9B}"/>
              </a:ext>
            </a:extLst>
          </p:cNvPr>
          <p:cNvSpPr txBox="1"/>
          <p:nvPr/>
        </p:nvSpPr>
        <p:spPr>
          <a:xfrm>
            <a:off x="1972037" y="5299914"/>
            <a:ext cx="25936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Abemaciclib Dose (</a:t>
            </a:r>
            <a:r>
              <a:rPr lang="en-US" sz="1600" dirty="0" err="1"/>
              <a:t>nM</a:t>
            </a:r>
            <a:r>
              <a:rPr lang="en-US" sz="1600" dirty="0"/>
              <a:t>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5B443A9-582F-D46E-3456-1F631B9EA4A2}"/>
              </a:ext>
            </a:extLst>
          </p:cNvPr>
          <p:cNvSpPr txBox="1"/>
          <p:nvPr/>
        </p:nvSpPr>
        <p:spPr>
          <a:xfrm>
            <a:off x="7552837" y="5299914"/>
            <a:ext cx="25936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Abemaciclib Dose (</a:t>
            </a:r>
            <a:r>
              <a:rPr lang="en-US" sz="1600" dirty="0" err="1"/>
              <a:t>nM</a:t>
            </a:r>
            <a:r>
              <a:rPr lang="en-US" sz="1600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59352079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E29AA4AD-A471-315C-EC7D-91E7628D988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1854" y="0"/>
            <a:ext cx="3657600" cy="27432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E5DFFE1-EA9F-0988-C746-D365F99B52A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85160" y="0"/>
            <a:ext cx="3657600" cy="27432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D9BB4A93-06B3-F76C-0C5A-8507374E6A5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608611" y="75724"/>
            <a:ext cx="4023360" cy="301752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02D7037E-5157-0B9B-565B-3077A50A4B3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121426" y="2756067"/>
            <a:ext cx="3657600" cy="274320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DFB73318-13A6-7D95-3C50-23C3B68D398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398686" y="2720348"/>
            <a:ext cx="3657600" cy="2743200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33E1D4DF-01FA-620A-FBFB-3A0D209CAEF9}"/>
              </a:ext>
            </a:extLst>
          </p:cNvPr>
          <p:cNvSpPr txBox="1"/>
          <p:nvPr/>
        </p:nvSpPr>
        <p:spPr>
          <a:xfrm>
            <a:off x="1486930" y="5592785"/>
            <a:ext cx="921814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 7: Densitometry Following Nocodazole Treatments for T47D cells. IGFBP-6 was tested with a Kruskal-Wallis Test. All other targets were statistically tested using ANOVA. </a:t>
            </a:r>
            <a:r>
              <a:rPr lang="en-US" dirty="0" err="1"/>
              <a:t>All</a:t>
            </a:r>
            <a:r>
              <a:rPr lang="en-US" dirty="0"/>
              <a:t> asterisks represent statistical significance relative to cells treated with the vehicle. * means p&lt; 0.05, *** means p&lt;0.01, and *** means p&lt;0.001. 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E4D16CE-5D95-2274-85F8-C7D275F2E55E}"/>
              </a:ext>
            </a:extLst>
          </p:cNvPr>
          <p:cNvSpPr txBox="1"/>
          <p:nvPr/>
        </p:nvSpPr>
        <p:spPr>
          <a:xfrm>
            <a:off x="9904053" y="1597443"/>
            <a:ext cx="3901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**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A9AB4B2-7AD3-9EDD-6AA0-1F0B7FD47115}"/>
              </a:ext>
            </a:extLst>
          </p:cNvPr>
          <p:cNvSpPr txBox="1"/>
          <p:nvPr/>
        </p:nvSpPr>
        <p:spPr>
          <a:xfrm>
            <a:off x="10435072" y="1585537"/>
            <a:ext cx="3901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**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4599B6C-7F54-D6DF-00C0-B7654433E686}"/>
              </a:ext>
            </a:extLst>
          </p:cNvPr>
          <p:cNvSpPr txBox="1"/>
          <p:nvPr/>
        </p:nvSpPr>
        <p:spPr>
          <a:xfrm>
            <a:off x="2926990" y="1535531"/>
            <a:ext cx="3901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***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8F50A8E-B94D-334D-45A1-703EC0A4A2F0}"/>
              </a:ext>
            </a:extLst>
          </p:cNvPr>
          <p:cNvSpPr txBox="1"/>
          <p:nvPr/>
        </p:nvSpPr>
        <p:spPr>
          <a:xfrm>
            <a:off x="6501246" y="1773656"/>
            <a:ext cx="3901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***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B35ECB6-1BCC-9EB0-C373-EC73E430970C}"/>
              </a:ext>
            </a:extLst>
          </p:cNvPr>
          <p:cNvSpPr txBox="1"/>
          <p:nvPr/>
        </p:nvSpPr>
        <p:spPr>
          <a:xfrm>
            <a:off x="6013090" y="1321218"/>
            <a:ext cx="3901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**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2C53DA5-349F-9039-C83B-DC09BA6FB61A}"/>
              </a:ext>
            </a:extLst>
          </p:cNvPr>
          <p:cNvSpPr txBox="1"/>
          <p:nvPr/>
        </p:nvSpPr>
        <p:spPr>
          <a:xfrm>
            <a:off x="3729471" y="4216818"/>
            <a:ext cx="3901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***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DB5E61F-B9FB-4463-6E2F-C85BEB88C639}"/>
              </a:ext>
            </a:extLst>
          </p:cNvPr>
          <p:cNvSpPr txBox="1"/>
          <p:nvPr/>
        </p:nvSpPr>
        <p:spPr>
          <a:xfrm>
            <a:off x="4200959" y="4502568"/>
            <a:ext cx="3901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***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D72608C-07EB-D526-1B65-6A436538270E}"/>
              </a:ext>
            </a:extLst>
          </p:cNvPr>
          <p:cNvSpPr txBox="1"/>
          <p:nvPr/>
        </p:nvSpPr>
        <p:spPr>
          <a:xfrm>
            <a:off x="4672446" y="4816894"/>
            <a:ext cx="3901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***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54ACE48-332A-2D19-EC01-64FA893C7958}"/>
              </a:ext>
            </a:extLst>
          </p:cNvPr>
          <p:cNvSpPr txBox="1"/>
          <p:nvPr/>
        </p:nvSpPr>
        <p:spPr>
          <a:xfrm>
            <a:off x="8413390" y="2714250"/>
            <a:ext cx="3901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*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2397C1D-CCAD-B676-D9F2-A96E49D347C5}"/>
              </a:ext>
            </a:extLst>
          </p:cNvPr>
          <p:cNvSpPr txBox="1"/>
          <p:nvPr/>
        </p:nvSpPr>
        <p:spPr>
          <a:xfrm>
            <a:off x="1006177" y="2631886"/>
            <a:ext cx="25936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Nocodazole Dose (</a:t>
            </a:r>
            <a:r>
              <a:rPr lang="en-US" sz="1600" dirty="0" err="1"/>
              <a:t>μM</a:t>
            </a:r>
            <a:r>
              <a:rPr lang="en-US" sz="1600" dirty="0"/>
              <a:t>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00C463B1-58FF-2B9B-4724-FD8965F9A955}"/>
              </a:ext>
            </a:extLst>
          </p:cNvPr>
          <p:cNvSpPr txBox="1"/>
          <p:nvPr/>
        </p:nvSpPr>
        <p:spPr>
          <a:xfrm>
            <a:off x="4672446" y="2631886"/>
            <a:ext cx="25936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Nocodazole Dose (</a:t>
            </a:r>
            <a:r>
              <a:rPr lang="en-US" sz="1600" dirty="0" err="1"/>
              <a:t>μM</a:t>
            </a:r>
            <a:r>
              <a:rPr lang="en-US" sz="1600" dirty="0"/>
              <a:t>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2061F2D9-0FDE-224D-4111-54FB8248A752}"/>
              </a:ext>
            </a:extLst>
          </p:cNvPr>
          <p:cNvSpPr txBox="1"/>
          <p:nvPr/>
        </p:nvSpPr>
        <p:spPr>
          <a:xfrm>
            <a:off x="8592155" y="2631886"/>
            <a:ext cx="25936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Nocodazole Dose (</a:t>
            </a:r>
            <a:r>
              <a:rPr lang="en-US" sz="1600" dirty="0" err="1"/>
              <a:t>μM</a:t>
            </a:r>
            <a:r>
              <a:rPr lang="en-US" sz="1600" dirty="0"/>
              <a:t>)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9BAF53CD-04D7-7B1C-90F9-6D5B6723788B}"/>
              </a:ext>
            </a:extLst>
          </p:cNvPr>
          <p:cNvSpPr txBox="1"/>
          <p:nvPr/>
        </p:nvSpPr>
        <p:spPr>
          <a:xfrm>
            <a:off x="2822825" y="5336970"/>
            <a:ext cx="25936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Nocodazole Dose (</a:t>
            </a:r>
            <a:r>
              <a:rPr lang="en-US" sz="1600" dirty="0" err="1"/>
              <a:t>μM</a:t>
            </a:r>
            <a:r>
              <a:rPr lang="en-US" sz="1600" dirty="0"/>
              <a:t>)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56A9023-11EE-B751-5BF0-10455AC28DEA}"/>
              </a:ext>
            </a:extLst>
          </p:cNvPr>
          <p:cNvSpPr txBox="1"/>
          <p:nvPr/>
        </p:nvSpPr>
        <p:spPr>
          <a:xfrm>
            <a:off x="7126480" y="5377035"/>
            <a:ext cx="25936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Nocodazole Dose (</a:t>
            </a:r>
            <a:r>
              <a:rPr lang="en-US" sz="1600" dirty="0" err="1"/>
              <a:t>μM</a:t>
            </a:r>
            <a:r>
              <a:rPr lang="en-US" sz="1600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292374901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>
            <a:extLst>
              <a:ext uri="{FF2B5EF4-FFF2-40B4-BE49-F238E27FC236}">
                <a16:creationId xmlns:a16="http://schemas.microsoft.com/office/drawing/2014/main" id="{F8372421-22D4-5B0D-D118-53EF352CE08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3762" y="-46731"/>
            <a:ext cx="3657600" cy="274320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9AF2F0B2-D55D-5701-A264-2EEE44B7371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83040" y="-46731"/>
            <a:ext cx="3657600" cy="274320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9939699C-CF97-B548-3FD3-FF096AF2866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282819" y="-32444"/>
            <a:ext cx="3657600" cy="274320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20AC6434-EAF9-50D2-3A35-0B8EDD48B59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678906" y="2798688"/>
            <a:ext cx="3657600" cy="2743200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721AFFA6-4722-91A7-2FC7-17F2954FC06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435523" y="2837895"/>
            <a:ext cx="3657600" cy="2743200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D8499F4E-0F3B-BF07-FD25-0FDB910C10F8}"/>
              </a:ext>
            </a:extLst>
          </p:cNvPr>
          <p:cNvSpPr txBox="1"/>
          <p:nvPr/>
        </p:nvSpPr>
        <p:spPr>
          <a:xfrm>
            <a:off x="850468" y="5817172"/>
            <a:ext cx="1052274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 8: Densitometry Following Nocodazole Treatments for MCF7 cells. All other targets were statistically tested using ANOVA. </a:t>
            </a:r>
            <a:r>
              <a:rPr lang="en-US" dirty="0" err="1"/>
              <a:t>All</a:t>
            </a:r>
            <a:r>
              <a:rPr lang="en-US" dirty="0"/>
              <a:t> asterisks represent statistical significance relative to cells treated with the vehicle. * means p&lt; 0.05, *** means p&lt;0.01, and *** means p&lt;0.001. 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FCCDBC6-69BD-CDDA-C9D1-241FDB206613}"/>
              </a:ext>
            </a:extLst>
          </p:cNvPr>
          <p:cNvSpPr txBox="1"/>
          <p:nvPr/>
        </p:nvSpPr>
        <p:spPr>
          <a:xfrm>
            <a:off x="10123959" y="910156"/>
            <a:ext cx="3901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**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DABD9E0-4095-D187-98F0-35978A0EF9DF}"/>
              </a:ext>
            </a:extLst>
          </p:cNvPr>
          <p:cNvSpPr txBox="1"/>
          <p:nvPr/>
        </p:nvSpPr>
        <p:spPr>
          <a:xfrm>
            <a:off x="10704984" y="1219718"/>
            <a:ext cx="3901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***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B31E4949-15EC-AE8C-723F-A86C111747A9}"/>
              </a:ext>
            </a:extLst>
          </p:cNvPr>
          <p:cNvSpPr txBox="1"/>
          <p:nvPr/>
        </p:nvSpPr>
        <p:spPr>
          <a:xfrm>
            <a:off x="3123082" y="1403074"/>
            <a:ext cx="3901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**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984388F-CD07-A9AB-346C-C1799B46D881}"/>
              </a:ext>
            </a:extLst>
          </p:cNvPr>
          <p:cNvSpPr txBox="1"/>
          <p:nvPr/>
        </p:nvSpPr>
        <p:spPr>
          <a:xfrm>
            <a:off x="2618257" y="883961"/>
            <a:ext cx="3901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*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F491EE67-2B90-5D28-7DA3-B9A09193C9A9}"/>
              </a:ext>
            </a:extLst>
          </p:cNvPr>
          <p:cNvSpPr txBox="1"/>
          <p:nvPr/>
        </p:nvSpPr>
        <p:spPr>
          <a:xfrm>
            <a:off x="4210482" y="3676274"/>
            <a:ext cx="3901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*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867AD5B-BAB6-4C71-9062-61B8F59EC080}"/>
              </a:ext>
            </a:extLst>
          </p:cNvPr>
          <p:cNvSpPr txBox="1"/>
          <p:nvPr/>
        </p:nvSpPr>
        <p:spPr>
          <a:xfrm>
            <a:off x="4698638" y="3750093"/>
            <a:ext cx="3901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*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E9B4EF1-9ABF-70E9-3FF3-79C0447B6836}"/>
              </a:ext>
            </a:extLst>
          </p:cNvPr>
          <p:cNvSpPr txBox="1"/>
          <p:nvPr/>
        </p:nvSpPr>
        <p:spPr>
          <a:xfrm>
            <a:off x="5201081" y="4602580"/>
            <a:ext cx="3901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***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9FAEEA65-CF97-A17E-A9D1-7F40FFEF1912}"/>
              </a:ext>
            </a:extLst>
          </p:cNvPr>
          <p:cNvSpPr txBox="1"/>
          <p:nvPr/>
        </p:nvSpPr>
        <p:spPr>
          <a:xfrm>
            <a:off x="1258620" y="2627305"/>
            <a:ext cx="25936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Nocodazole Dose (</a:t>
            </a:r>
            <a:r>
              <a:rPr lang="en-US" sz="1600" dirty="0" err="1"/>
              <a:t>μM</a:t>
            </a:r>
            <a:r>
              <a:rPr lang="en-US" sz="1600" dirty="0"/>
              <a:t>)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B48CC73-4C06-E833-C386-24125CC07CED}"/>
              </a:ext>
            </a:extLst>
          </p:cNvPr>
          <p:cNvSpPr txBox="1"/>
          <p:nvPr/>
        </p:nvSpPr>
        <p:spPr>
          <a:xfrm>
            <a:off x="5039672" y="2626363"/>
            <a:ext cx="25936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Nocodazole Dose (</a:t>
            </a:r>
            <a:r>
              <a:rPr lang="en-US" sz="1600" dirty="0" err="1"/>
              <a:t>μM</a:t>
            </a:r>
            <a:r>
              <a:rPr lang="en-US" sz="1600" dirty="0"/>
              <a:t>)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B250B65-7A14-37FE-DBA3-0B069B01605C}"/>
              </a:ext>
            </a:extLst>
          </p:cNvPr>
          <p:cNvSpPr txBox="1"/>
          <p:nvPr/>
        </p:nvSpPr>
        <p:spPr>
          <a:xfrm>
            <a:off x="9022219" y="2626363"/>
            <a:ext cx="25936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Nocodazole Dose (</a:t>
            </a:r>
            <a:r>
              <a:rPr lang="en-US" sz="1600" dirty="0" err="1"/>
              <a:t>μM</a:t>
            </a:r>
            <a:r>
              <a:rPr lang="en-US" sz="1600" dirty="0"/>
              <a:t>)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069F04B4-FE62-5F1D-34AC-2AE6D26D0C99}"/>
              </a:ext>
            </a:extLst>
          </p:cNvPr>
          <p:cNvSpPr txBox="1"/>
          <p:nvPr/>
        </p:nvSpPr>
        <p:spPr>
          <a:xfrm>
            <a:off x="3401804" y="5426350"/>
            <a:ext cx="25936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Nocodazole Dose (</a:t>
            </a:r>
            <a:r>
              <a:rPr lang="en-US" sz="1600" dirty="0" err="1"/>
              <a:t>μM</a:t>
            </a:r>
            <a:r>
              <a:rPr lang="en-US" sz="1600" dirty="0"/>
              <a:t>)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79BBE3A1-8A40-C02A-F9E9-70620A1BED34}"/>
              </a:ext>
            </a:extLst>
          </p:cNvPr>
          <p:cNvSpPr txBox="1"/>
          <p:nvPr/>
        </p:nvSpPr>
        <p:spPr>
          <a:xfrm>
            <a:off x="7091408" y="5426350"/>
            <a:ext cx="25936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dirty="0"/>
              <a:t>Nocodazole Dose (</a:t>
            </a:r>
            <a:r>
              <a:rPr lang="en-US" sz="1600" dirty="0" err="1"/>
              <a:t>μM</a:t>
            </a:r>
            <a:r>
              <a:rPr lang="en-US" sz="1600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199308498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330A939-0943-129C-494C-576E03DD4886}"/>
              </a:ext>
            </a:extLst>
          </p:cNvPr>
          <p:cNvSpPr txBox="1"/>
          <p:nvPr/>
        </p:nvSpPr>
        <p:spPr>
          <a:xfrm>
            <a:off x="2461317" y="6179909"/>
            <a:ext cx="63870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Fig 9: SH2D4A levels in MCF7 and T47D cells following Abemaciclib and Nocodazole treatments.</a:t>
            </a:r>
          </a:p>
        </p:txBody>
      </p:sp>
      <p:pic>
        <p:nvPicPr>
          <p:cNvPr id="4" name="Picture 3" descr="The image is not provided, so I can't describe it.&#10;&#10;AI-generated content may be incorrect.">
            <a:extLst>
              <a:ext uri="{FF2B5EF4-FFF2-40B4-BE49-F238E27FC236}">
                <a16:creationId xmlns:a16="http://schemas.microsoft.com/office/drawing/2014/main" id="{83DEF488-AAC6-D50A-8DB7-589F9DCD2488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7926" t="39378" r="38466" b="44280"/>
          <a:stretch>
            <a:fillRect/>
          </a:stretch>
        </p:blipFill>
        <p:spPr>
          <a:xfrm>
            <a:off x="1793476" y="1417306"/>
            <a:ext cx="2413584" cy="81816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42BDFCF-8E3A-0E90-4E4A-3EAB05143030}"/>
              </a:ext>
            </a:extLst>
          </p:cNvPr>
          <p:cNvSpPr txBox="1"/>
          <p:nvPr/>
        </p:nvSpPr>
        <p:spPr>
          <a:xfrm>
            <a:off x="2050839" y="124569"/>
            <a:ext cx="19396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MCF7 </a:t>
            </a:r>
            <a:r>
              <a:rPr lang="en-US" dirty="0" err="1"/>
              <a:t>Abemaclib</a:t>
            </a:r>
            <a:endParaRPr lang="en-US" dirty="0"/>
          </a:p>
        </p:txBody>
      </p:sp>
      <p:pic>
        <p:nvPicPr>
          <p:cNvPr id="7" name="Picture 6" descr="The image is a black and white depiction of a single, isolated line or bar.&#10;&#10;AI-generated content may be incorrect.">
            <a:extLst>
              <a:ext uri="{FF2B5EF4-FFF2-40B4-BE49-F238E27FC236}">
                <a16:creationId xmlns:a16="http://schemas.microsoft.com/office/drawing/2014/main" id="{526DB211-52FF-697C-AC39-F8FE7072C676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29066" t="50000" r="37468" b="36926"/>
          <a:stretch>
            <a:fillRect/>
          </a:stretch>
        </p:blipFill>
        <p:spPr>
          <a:xfrm>
            <a:off x="1793476" y="2241811"/>
            <a:ext cx="2403358" cy="654531"/>
          </a:xfrm>
          <a:prstGeom prst="rect">
            <a:avLst/>
          </a:prstGeom>
        </p:spPr>
      </p:pic>
      <p:pic>
        <p:nvPicPr>
          <p:cNvPr id="9" name="Picture 8" descr="The image is a black and white image of two horizontal lines, likely representing a barcode or a striped pattern.&#10;&#10;AI-generated content may be incorrect.">
            <a:extLst>
              <a:ext uri="{FF2B5EF4-FFF2-40B4-BE49-F238E27FC236}">
                <a16:creationId xmlns:a16="http://schemas.microsoft.com/office/drawing/2014/main" id="{2F83B3FC-F15C-9334-2C79-12935572C6FE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44019" t="45554" r="22372" b="40146"/>
          <a:stretch>
            <a:fillRect/>
          </a:stretch>
        </p:blipFill>
        <p:spPr>
          <a:xfrm>
            <a:off x="6035958" y="1430080"/>
            <a:ext cx="2535382" cy="752020"/>
          </a:xfrm>
          <a:prstGeom prst="rect">
            <a:avLst/>
          </a:prstGeom>
        </p:spPr>
      </p:pic>
      <p:pic>
        <p:nvPicPr>
          <p:cNvPr id="11" name="Picture 10" descr="The image appears to be a black and white silhouette with a series of vertical lines, possibly representing a striped pattern or a structured grid.&#10;&#10;AI-generated content may be incorrect.">
            <a:extLst>
              <a:ext uri="{FF2B5EF4-FFF2-40B4-BE49-F238E27FC236}">
                <a16:creationId xmlns:a16="http://schemas.microsoft.com/office/drawing/2014/main" id="{97CE7938-D643-6185-F8F9-805EE0602B2B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42879" t="48414" r="23512" b="37286"/>
          <a:stretch>
            <a:fillRect/>
          </a:stretch>
        </p:blipFill>
        <p:spPr>
          <a:xfrm>
            <a:off x="6035958" y="2188045"/>
            <a:ext cx="2535382" cy="752020"/>
          </a:xfrm>
          <a:prstGeom prst="rect">
            <a:avLst/>
          </a:prstGeom>
        </p:spPr>
      </p:pic>
      <p:pic>
        <p:nvPicPr>
          <p:cNvPr id="14" name="Picture 13" descr="The image is a black and white striped DNA ladder, likely a gel electrophoresis result.&#10;&#10;AI-generated content may be incorrect.">
            <a:extLst>
              <a:ext uri="{FF2B5EF4-FFF2-40B4-BE49-F238E27FC236}">
                <a16:creationId xmlns:a16="http://schemas.microsoft.com/office/drawing/2014/main" id="{09DE0208-78EB-CFF5-5C78-ACBC21878E22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24163" t="31819" r="46582" b="55516"/>
          <a:stretch>
            <a:fillRect/>
          </a:stretch>
        </p:blipFill>
        <p:spPr>
          <a:xfrm>
            <a:off x="6048457" y="4307620"/>
            <a:ext cx="2611378" cy="788143"/>
          </a:xfrm>
          <a:prstGeom prst="rect">
            <a:avLst/>
          </a:prstGeom>
        </p:spPr>
      </p:pic>
      <p:pic>
        <p:nvPicPr>
          <p:cNvPr id="16" name="Picture 15" descr="The image is a black and white striped pattern, possibly a series of uniform lines or bars.&#10;&#10;AI-generated content may be incorrect.">
            <a:extLst>
              <a:ext uri="{FF2B5EF4-FFF2-40B4-BE49-F238E27FC236}">
                <a16:creationId xmlns:a16="http://schemas.microsoft.com/office/drawing/2014/main" id="{DDA398FB-A77C-FBBD-5AA6-769C26DBC6B1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l="15680" t="28142" r="53987" b="57558"/>
          <a:stretch>
            <a:fillRect/>
          </a:stretch>
        </p:blipFill>
        <p:spPr>
          <a:xfrm>
            <a:off x="6043009" y="5083653"/>
            <a:ext cx="2611377" cy="858199"/>
          </a:xfrm>
          <a:prstGeom prst="rect">
            <a:avLst/>
          </a:prstGeom>
        </p:spPr>
      </p:pic>
      <p:pic>
        <p:nvPicPr>
          <p:cNvPr id="18" name="Picture 17" descr="The image appears to be a black and white image with a series of horizontal lines, possibly representing a barcode or a DNA sequencing pattern.&#10;&#10;AI-generated content may be incorrect.">
            <a:extLst>
              <a:ext uri="{FF2B5EF4-FFF2-40B4-BE49-F238E27FC236}">
                <a16:creationId xmlns:a16="http://schemas.microsoft.com/office/drawing/2014/main" id="{FC9EF67C-ED7C-81B8-01BE-03B4CA20B094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 l="18670" t="33453" r="47721" b="54290"/>
          <a:stretch>
            <a:fillRect/>
          </a:stretch>
        </p:blipFill>
        <p:spPr>
          <a:xfrm>
            <a:off x="1814289" y="4310053"/>
            <a:ext cx="2397014" cy="609410"/>
          </a:xfrm>
          <a:prstGeom prst="rect">
            <a:avLst/>
          </a:prstGeom>
        </p:spPr>
      </p:pic>
      <p:pic>
        <p:nvPicPr>
          <p:cNvPr id="20" name="Picture 19" descr="The image appears to be a black and white striped pattern, possibly a barcode or a line of molecular markers.&#10;&#10;AI-generated content may be incorrect.">
            <a:extLst>
              <a:ext uri="{FF2B5EF4-FFF2-40B4-BE49-F238E27FC236}">
                <a16:creationId xmlns:a16="http://schemas.microsoft.com/office/drawing/2014/main" id="{D6276C53-5485-9B32-73D7-E093B5783F8F}"/>
              </a:ext>
            </a:extLst>
          </p:cNvPr>
          <p:cNvPicPr>
            <a:picLocks noChangeAspect="1"/>
          </p:cNvPicPr>
          <p:nvPr/>
        </p:nvPicPr>
        <p:blipFill>
          <a:blip r:embed="rId9"/>
          <a:srcRect l="13971" t="34679" r="54414" b="53677"/>
          <a:stretch>
            <a:fillRect/>
          </a:stretch>
        </p:blipFill>
        <p:spPr>
          <a:xfrm>
            <a:off x="1810046" y="4931573"/>
            <a:ext cx="2397014" cy="615448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D4B2E55D-A37F-1544-DBBE-C64ABFDA53BD}"/>
              </a:ext>
            </a:extLst>
          </p:cNvPr>
          <p:cNvSpPr txBox="1"/>
          <p:nvPr/>
        </p:nvSpPr>
        <p:spPr>
          <a:xfrm>
            <a:off x="2015453" y="3088096"/>
            <a:ext cx="20700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MCF7 Nocodazole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5F49FF9D-2381-CA13-2161-7D4B563FC81E}"/>
              </a:ext>
            </a:extLst>
          </p:cNvPr>
          <p:cNvSpPr txBox="1"/>
          <p:nvPr/>
        </p:nvSpPr>
        <p:spPr>
          <a:xfrm rot="16200000">
            <a:off x="1707745" y="768580"/>
            <a:ext cx="928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CBC2216-B559-A33A-5827-00C00C9A3332}"/>
              </a:ext>
            </a:extLst>
          </p:cNvPr>
          <p:cNvSpPr txBox="1"/>
          <p:nvPr/>
        </p:nvSpPr>
        <p:spPr>
          <a:xfrm rot="16200000">
            <a:off x="2229645" y="767036"/>
            <a:ext cx="928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5 </a:t>
            </a:r>
            <a:r>
              <a:rPr lang="en-US" dirty="0" err="1"/>
              <a:t>nM</a:t>
            </a:r>
            <a:endParaRPr lang="en-US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6FF5F75A-ACFB-8169-8D82-9A9D45054B66}"/>
              </a:ext>
            </a:extLst>
          </p:cNvPr>
          <p:cNvSpPr txBox="1"/>
          <p:nvPr/>
        </p:nvSpPr>
        <p:spPr>
          <a:xfrm rot="16200000">
            <a:off x="2773643" y="779416"/>
            <a:ext cx="928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5 0 </a:t>
            </a:r>
            <a:r>
              <a:rPr lang="en-US" dirty="0" err="1"/>
              <a:t>nM</a:t>
            </a:r>
            <a:endParaRPr lang="en-US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3CF0D87-3E46-1112-60E4-D6C61C007930}"/>
              </a:ext>
            </a:extLst>
          </p:cNvPr>
          <p:cNvSpPr txBox="1"/>
          <p:nvPr/>
        </p:nvSpPr>
        <p:spPr>
          <a:xfrm rot="16200000">
            <a:off x="3302212" y="768646"/>
            <a:ext cx="928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500 </a:t>
            </a:r>
            <a:r>
              <a:rPr lang="en-US" dirty="0" err="1"/>
              <a:t>nM</a:t>
            </a:r>
            <a:endParaRPr lang="en-US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BC31CEC-B78E-29F0-0B36-D3BDA4D6C215}"/>
              </a:ext>
            </a:extLst>
          </p:cNvPr>
          <p:cNvSpPr txBox="1"/>
          <p:nvPr/>
        </p:nvSpPr>
        <p:spPr>
          <a:xfrm rot="16200000">
            <a:off x="5973509" y="785234"/>
            <a:ext cx="928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B47A66CD-C2F1-7BF3-9CD4-88242BCE9EDE}"/>
              </a:ext>
            </a:extLst>
          </p:cNvPr>
          <p:cNvSpPr txBox="1"/>
          <p:nvPr/>
        </p:nvSpPr>
        <p:spPr>
          <a:xfrm rot="16200000">
            <a:off x="6560251" y="758681"/>
            <a:ext cx="928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5 </a:t>
            </a:r>
            <a:r>
              <a:rPr lang="en-US" dirty="0" err="1"/>
              <a:t>nM</a:t>
            </a:r>
            <a:endParaRPr lang="en-US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3896EDED-92C1-6D1B-0669-7A111B4DF292}"/>
              </a:ext>
            </a:extLst>
          </p:cNvPr>
          <p:cNvSpPr txBox="1"/>
          <p:nvPr/>
        </p:nvSpPr>
        <p:spPr>
          <a:xfrm rot="16200000">
            <a:off x="7144374" y="775342"/>
            <a:ext cx="928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5 0 </a:t>
            </a:r>
            <a:r>
              <a:rPr lang="en-US" dirty="0" err="1"/>
              <a:t>nM</a:t>
            </a:r>
            <a:endParaRPr lang="en-US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E6D8D51-559B-E518-8550-FCE5DD2E9A1D}"/>
              </a:ext>
            </a:extLst>
          </p:cNvPr>
          <p:cNvSpPr txBox="1"/>
          <p:nvPr/>
        </p:nvSpPr>
        <p:spPr>
          <a:xfrm rot="16200000">
            <a:off x="7736752" y="785234"/>
            <a:ext cx="928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500 </a:t>
            </a:r>
            <a:r>
              <a:rPr lang="en-US" dirty="0" err="1"/>
              <a:t>nM</a:t>
            </a:r>
            <a:endParaRPr lang="en-US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34DFD704-402B-08DE-DB2E-8E42C85E45C5}"/>
              </a:ext>
            </a:extLst>
          </p:cNvPr>
          <p:cNvSpPr txBox="1"/>
          <p:nvPr/>
        </p:nvSpPr>
        <p:spPr>
          <a:xfrm rot="16200000">
            <a:off x="1693362" y="3670674"/>
            <a:ext cx="928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AB1BC494-1FF9-368B-058D-282327CFDFCC}"/>
              </a:ext>
            </a:extLst>
          </p:cNvPr>
          <p:cNvSpPr txBox="1"/>
          <p:nvPr/>
        </p:nvSpPr>
        <p:spPr>
          <a:xfrm rot="16200000">
            <a:off x="2229645" y="3670674"/>
            <a:ext cx="928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00 </a:t>
            </a:r>
            <a:r>
              <a:rPr lang="en-US" dirty="0" err="1"/>
              <a:t>nM</a:t>
            </a:r>
            <a:endParaRPr lang="en-US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DF75C3F2-BA23-2F41-7766-7E9B97F717C8}"/>
              </a:ext>
            </a:extLst>
          </p:cNvPr>
          <p:cNvSpPr txBox="1"/>
          <p:nvPr/>
        </p:nvSpPr>
        <p:spPr>
          <a:xfrm rot="16200000">
            <a:off x="2771029" y="3665967"/>
            <a:ext cx="928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 </a:t>
            </a:r>
            <a:r>
              <a:rPr lang="en-US" dirty="0" err="1"/>
              <a:t>μM</a:t>
            </a:r>
            <a:endParaRPr lang="en-US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4481E9D3-2651-10EB-14DD-AE449C11027E}"/>
              </a:ext>
            </a:extLst>
          </p:cNvPr>
          <p:cNvSpPr txBox="1"/>
          <p:nvPr/>
        </p:nvSpPr>
        <p:spPr>
          <a:xfrm rot="16200000">
            <a:off x="3302212" y="3670674"/>
            <a:ext cx="928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0 </a:t>
            </a:r>
            <a:r>
              <a:rPr lang="en-US" dirty="0" err="1"/>
              <a:t>μM</a:t>
            </a:r>
            <a:endParaRPr lang="en-US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FC5CA985-EA21-5455-5D83-90E42B09D911}"/>
              </a:ext>
            </a:extLst>
          </p:cNvPr>
          <p:cNvSpPr txBox="1"/>
          <p:nvPr/>
        </p:nvSpPr>
        <p:spPr>
          <a:xfrm rot="16200000">
            <a:off x="5931961" y="3683565"/>
            <a:ext cx="928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MSO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BE028DAA-88E0-057F-66E8-2A9B82BA665F}"/>
              </a:ext>
            </a:extLst>
          </p:cNvPr>
          <p:cNvSpPr txBox="1"/>
          <p:nvPr/>
        </p:nvSpPr>
        <p:spPr>
          <a:xfrm rot="16200000">
            <a:off x="6643472" y="3660648"/>
            <a:ext cx="928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00 </a:t>
            </a:r>
            <a:r>
              <a:rPr lang="en-US" dirty="0" err="1"/>
              <a:t>nM</a:t>
            </a:r>
            <a:endParaRPr lang="en-US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A9116772-9444-ACC5-6772-A4FE724AD12F}"/>
              </a:ext>
            </a:extLst>
          </p:cNvPr>
          <p:cNvSpPr txBox="1"/>
          <p:nvPr/>
        </p:nvSpPr>
        <p:spPr>
          <a:xfrm rot="16200000">
            <a:off x="7301422" y="3683566"/>
            <a:ext cx="928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 </a:t>
            </a:r>
            <a:r>
              <a:rPr lang="en-US" dirty="0" err="1"/>
              <a:t>μM</a:t>
            </a:r>
            <a:endParaRPr lang="en-US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D04F1042-32E5-32E6-5E33-FDACF031C5E0}"/>
              </a:ext>
            </a:extLst>
          </p:cNvPr>
          <p:cNvSpPr txBox="1"/>
          <p:nvPr/>
        </p:nvSpPr>
        <p:spPr>
          <a:xfrm rot="16200000">
            <a:off x="7878658" y="3666721"/>
            <a:ext cx="928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10 </a:t>
            </a:r>
            <a:r>
              <a:rPr lang="en-US" dirty="0" err="1"/>
              <a:t>μM</a:t>
            </a:r>
            <a:endParaRPr lang="en-US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AF4AAB97-6AD3-3E96-4001-406A392F415D}"/>
              </a:ext>
            </a:extLst>
          </p:cNvPr>
          <p:cNvSpPr txBox="1"/>
          <p:nvPr/>
        </p:nvSpPr>
        <p:spPr>
          <a:xfrm>
            <a:off x="6202291" y="118270"/>
            <a:ext cx="19396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T47D </a:t>
            </a:r>
            <a:r>
              <a:rPr lang="en-US" dirty="0" err="1"/>
              <a:t>Abemaclib</a:t>
            </a:r>
            <a:endParaRPr lang="en-US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5C94B460-9C57-54B6-23BB-DEC500BC6168}"/>
              </a:ext>
            </a:extLst>
          </p:cNvPr>
          <p:cNvSpPr txBox="1"/>
          <p:nvPr/>
        </p:nvSpPr>
        <p:spPr>
          <a:xfrm>
            <a:off x="6285002" y="3021881"/>
            <a:ext cx="20700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T47D Nocodazole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20E3F76E-4ADB-E297-EE21-566B0B7A5F4B}"/>
              </a:ext>
            </a:extLst>
          </p:cNvPr>
          <p:cNvSpPr txBox="1"/>
          <p:nvPr/>
        </p:nvSpPr>
        <p:spPr>
          <a:xfrm>
            <a:off x="705895" y="1607127"/>
            <a:ext cx="1087581" cy="3671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/>
              <a:t>SH2D4A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0FBB88F1-5503-4F5D-2EA4-261D1DDA8C01}"/>
              </a:ext>
            </a:extLst>
          </p:cNvPr>
          <p:cNvSpPr txBox="1"/>
          <p:nvPr/>
        </p:nvSpPr>
        <p:spPr>
          <a:xfrm>
            <a:off x="705894" y="2250011"/>
            <a:ext cx="108758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/>
              <a:t>Beta Actin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502AA188-3056-6F81-B571-E89ECE97A625}"/>
              </a:ext>
            </a:extLst>
          </p:cNvPr>
          <p:cNvSpPr txBox="1"/>
          <p:nvPr/>
        </p:nvSpPr>
        <p:spPr>
          <a:xfrm>
            <a:off x="4955429" y="1548316"/>
            <a:ext cx="1087581" cy="3671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/>
              <a:t>SH2D4A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08070E67-8258-B17E-B42D-433FB808EB5E}"/>
              </a:ext>
            </a:extLst>
          </p:cNvPr>
          <p:cNvSpPr txBox="1"/>
          <p:nvPr/>
        </p:nvSpPr>
        <p:spPr>
          <a:xfrm>
            <a:off x="4955428" y="2191200"/>
            <a:ext cx="108758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/>
              <a:t>Beta Actin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54F6E732-7DA4-E69C-C0FE-F5AD1805F900}"/>
              </a:ext>
            </a:extLst>
          </p:cNvPr>
          <p:cNvSpPr txBox="1"/>
          <p:nvPr/>
        </p:nvSpPr>
        <p:spPr>
          <a:xfrm>
            <a:off x="726709" y="4452879"/>
            <a:ext cx="1087581" cy="3671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/>
              <a:t>SH2D4A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AFB6C5BC-4AFF-A08A-9FC8-01121F0FC730}"/>
              </a:ext>
            </a:extLst>
          </p:cNvPr>
          <p:cNvSpPr txBox="1"/>
          <p:nvPr/>
        </p:nvSpPr>
        <p:spPr>
          <a:xfrm>
            <a:off x="726709" y="4912800"/>
            <a:ext cx="108758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/>
              <a:t>Beta Actin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613B7053-6064-8AE9-A5E7-3886F1D635A8}"/>
              </a:ext>
            </a:extLst>
          </p:cNvPr>
          <p:cNvSpPr txBox="1"/>
          <p:nvPr/>
        </p:nvSpPr>
        <p:spPr>
          <a:xfrm>
            <a:off x="4958152" y="4614956"/>
            <a:ext cx="1087581" cy="36714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/>
              <a:t>SH2D4A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CDC76B95-44DC-0CEF-DAFD-625D50503216}"/>
              </a:ext>
            </a:extLst>
          </p:cNvPr>
          <p:cNvSpPr txBox="1"/>
          <p:nvPr/>
        </p:nvSpPr>
        <p:spPr>
          <a:xfrm>
            <a:off x="4958151" y="5257840"/>
            <a:ext cx="108758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/>
              <a:t>Beta Actin</a:t>
            </a:r>
          </a:p>
        </p:txBody>
      </p:sp>
    </p:spTree>
    <p:extLst>
      <p:ext uri="{BB962C8B-B14F-4D97-AF65-F5344CB8AC3E}">
        <p14:creationId xmlns:p14="http://schemas.microsoft.com/office/powerpoint/2010/main" val="36151968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971</TotalTime>
  <Words>561</Words>
  <Application>Microsoft Macintosh PowerPoint</Application>
  <PresentationFormat>Widescreen</PresentationFormat>
  <Paragraphs>129</Paragraphs>
  <Slides>1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7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Francisco Lariz</dc:creator>
  <cp:lastModifiedBy>Kevin Houston</cp:lastModifiedBy>
  <cp:revision>74</cp:revision>
  <dcterms:created xsi:type="dcterms:W3CDTF">2026-01-26T03:05:27Z</dcterms:created>
  <dcterms:modified xsi:type="dcterms:W3CDTF">2026-06-01T16:30:43Z</dcterms:modified>
</cp:coreProperties>
</file>